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8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617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4917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44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60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178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5830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0009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992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494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2693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664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8ECEC-DE40-4701-AE29-5E36A6639E95}" type="datetimeFigureOut">
              <a:rPr lang="en-AU" smtClean="0"/>
              <a:t>2/03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776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1" descr="A (1)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8667" y="878417"/>
            <a:ext cx="7905750" cy="44465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2409296" y="5299077"/>
            <a:ext cx="6997701" cy="13906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relation between Lipid Fold Change and PSA-PFS Time.</a:t>
            </a: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Scatter plots showing the significant negative correlation between the fold change of several treatment-altered triacylglycerol (TG) species and PSA-PFS time, supporting their role as promising candidates associated with clinical outcome. (B) Scatter plots showing the significant positive correlation between the total fold change of all measured Oxidized Species (</a:t>
            </a:r>
            <a:r>
              <a:rPr kumimoji="0" lang="en-US" altLang="en-US" sz="9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xSpecies</a:t>
            </a:r>
            <a:r>
              <a:rPr kumimoji="0" lang="en-US" altLang="en-US" sz="9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Sphingomyelins (SM) and PSA-PFS time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 Box 3"/>
          <p:cNvSpPr txBox="1">
            <a:spLocks noChangeArrowheads="1"/>
          </p:cNvSpPr>
          <p:nvPr/>
        </p:nvSpPr>
        <p:spPr bwMode="auto">
          <a:xfrm>
            <a:off x="3310467" y="819680"/>
            <a:ext cx="7904163" cy="4572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altLang="en-US" sz="9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kumimoji="0" lang="en-US" altLang="en-US" sz="900" b="0" i="1" u="none" strike="noStrike" cap="none" normalizeH="0" baseline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1608667" y="13546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4174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V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ak Talmor - SVHNS</dc:creator>
  <cp:lastModifiedBy>Barak Talmor - SVHNS</cp:lastModifiedBy>
  <cp:revision>7</cp:revision>
  <dcterms:created xsi:type="dcterms:W3CDTF">2026-02-22T23:33:58Z</dcterms:created>
  <dcterms:modified xsi:type="dcterms:W3CDTF">2026-03-01T23:28:29Z</dcterms:modified>
</cp:coreProperties>
</file>